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1566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C17C78-9DBB-364E-A4F4-5649051A287D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E672E7-092F-604E-9058-FBDF65DD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7838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ame primer set,</a:t>
            </a:r>
            <a:r>
              <a:rPr lang="en-US" baseline="0" dirty="0" smtClean="0"/>
              <a:t> annealing temp, and PCR cycle # </a:t>
            </a:r>
            <a:r>
              <a:rPr lang="en-US" dirty="0" smtClean="0"/>
              <a:t>as used in </a:t>
            </a:r>
            <a:r>
              <a:rPr lang="en-US" dirty="0" err="1" smtClean="0"/>
              <a:t>semiquantitative</a:t>
            </a:r>
            <a:r>
              <a:rPr lang="en-US" dirty="0" smtClean="0"/>
              <a:t> PCR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E672E7-092F-604E-9058-FBDF65DDD1C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062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955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027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021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7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625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95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135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15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895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417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686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1ABE5-B91D-574B-BA9A-AD0A625D6AEC}" type="datetimeFigureOut">
              <a:rPr lang="en-US" smtClean="0"/>
              <a:t>9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CD34A5-AE5A-0942-AE81-104E7F0C1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336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9.8.17 mimulus pcr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64077" b="28998"/>
          <a:stretch/>
        </p:blipFill>
        <p:spPr>
          <a:xfrm>
            <a:off x="2790918" y="1006226"/>
            <a:ext cx="2109321" cy="391746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2643550" y="1410572"/>
            <a:ext cx="1100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100bp Ladder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2803007" y="1871350"/>
            <a:ext cx="1514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L01707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-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614667" y="3973725"/>
            <a:ext cx="816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  <a:latin typeface="Times New Roman"/>
                <a:cs typeface="Times New Roman"/>
              </a:rPr>
              <a:t>IM62</a:t>
            </a:r>
            <a:endParaRPr lang="en-US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846395" y="1561668"/>
            <a:ext cx="2134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L01707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-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3509148" y="1871350"/>
            <a:ext cx="1514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J00652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</a:t>
            </a:r>
            <a:r>
              <a:rPr lang="en-US" sz="1200" dirty="0">
                <a:solidFill>
                  <a:schemeClr val="bg1"/>
                </a:solidFill>
                <a:latin typeface="Times New Roman"/>
                <a:cs typeface="Times New Roman"/>
              </a:rPr>
              <a:t>+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3862217" y="1871350"/>
            <a:ext cx="1514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J00652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</a:t>
            </a:r>
            <a:r>
              <a:rPr lang="en-US" sz="1200" dirty="0">
                <a:solidFill>
                  <a:schemeClr val="bg1"/>
                </a:solidFill>
                <a:latin typeface="Times New Roman"/>
                <a:cs typeface="Times New Roman"/>
              </a:rPr>
              <a:t>+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4294848" y="1871350"/>
            <a:ext cx="1514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Actin rep1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4644328" y="1871350"/>
            <a:ext cx="1514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Actin rep2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5062435" y="1871350"/>
            <a:ext cx="1514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L01707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-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5361167" y="1871350"/>
            <a:ext cx="1514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L.01707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-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pic>
        <p:nvPicPr>
          <p:cNvPr id="33" name="Picture 32" descr="9.8.17 mimulus pcr.ti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502" r="26144" b="28998"/>
          <a:stretch/>
        </p:blipFill>
        <p:spPr>
          <a:xfrm>
            <a:off x="4958860" y="1006226"/>
            <a:ext cx="1547446" cy="3917466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5279341" y="3973725"/>
            <a:ext cx="816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bg1"/>
                </a:solidFill>
                <a:latin typeface="Times New Roman"/>
                <a:cs typeface="Times New Roman"/>
              </a:rPr>
              <a:t>IM767</a:t>
            </a:r>
            <a:endParaRPr lang="en-US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4432515" y="1871350"/>
            <a:ext cx="1514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L01707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-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36" name="TextBox 35"/>
          <p:cNvSpPr txBox="1"/>
          <p:nvPr/>
        </p:nvSpPr>
        <p:spPr>
          <a:xfrm rot="16200000">
            <a:off x="4475903" y="1561668"/>
            <a:ext cx="2134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L01707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-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5138656" y="1871350"/>
            <a:ext cx="1514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J00652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</a:t>
            </a:r>
            <a:r>
              <a:rPr lang="en-US" sz="1200" dirty="0">
                <a:solidFill>
                  <a:schemeClr val="bg1"/>
                </a:solidFill>
                <a:latin typeface="Times New Roman"/>
                <a:cs typeface="Times New Roman"/>
              </a:rPr>
              <a:t>+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5491725" y="1871350"/>
            <a:ext cx="1514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Migut.J00652 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(</a:t>
            </a:r>
            <a:r>
              <a:rPr lang="en-US" sz="1200" dirty="0">
                <a:solidFill>
                  <a:schemeClr val="bg1"/>
                </a:solidFill>
                <a:latin typeface="Times New Roman"/>
                <a:cs typeface="Times New Roman"/>
              </a:rPr>
              <a:t>+</a:t>
            </a:r>
            <a:r>
              <a:rPr lang="en-US" sz="1200" dirty="0" smtClean="0">
                <a:solidFill>
                  <a:schemeClr val="bg1"/>
                </a:solidFill>
                <a:latin typeface="Times New Roman"/>
                <a:cs typeface="Times New Roman"/>
              </a:rPr>
              <a:t>I7)</a:t>
            </a:r>
            <a:endParaRPr lang="en-US" sz="1200" dirty="0">
              <a:solidFill>
                <a:schemeClr val="bg1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5275732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7</TotalTime>
  <Words>66</Words>
  <Application>Microsoft Office PowerPoint</Application>
  <PresentationFormat>On-screen Show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Spiekerman</dc:creator>
  <cp:lastModifiedBy>Katrien Devos</cp:lastModifiedBy>
  <cp:revision>11</cp:revision>
  <dcterms:created xsi:type="dcterms:W3CDTF">2017-09-08T19:58:37Z</dcterms:created>
  <dcterms:modified xsi:type="dcterms:W3CDTF">2017-09-24T16:38:34Z</dcterms:modified>
</cp:coreProperties>
</file>